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3" r:id="rId3"/>
    <p:sldId id="259" r:id="rId4"/>
    <p:sldId id="262" r:id="rId5"/>
    <p:sldId id="261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39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64" autoAdjust="0"/>
    <p:restoredTop sz="99015" autoAdjust="0"/>
  </p:normalViewPr>
  <p:slideViewPr>
    <p:cSldViewPr showGuides="1">
      <p:cViewPr>
        <p:scale>
          <a:sx n="130" d="100"/>
          <a:sy n="130" d="100"/>
        </p:scale>
        <p:origin x="2214" y="-438"/>
      </p:cViewPr>
      <p:guideLst>
        <p:guide orient="horz" pos="3120"/>
        <p:guide pos="39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07384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46716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0915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7119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47365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6494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7081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7758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33816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4237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4825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86BE4E-ACE3-455F-AA43-5D1FD0205636}" type="datetimeFigureOut">
              <a:rPr lang="en-GB" smtClean="0"/>
              <a:t>14/06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E7C6AC-8F83-496A-97A6-D38AC13C1B0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8719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/>
          <p:cNvGrpSpPr/>
          <p:nvPr/>
        </p:nvGrpSpPr>
        <p:grpSpPr>
          <a:xfrm>
            <a:off x="692696" y="632521"/>
            <a:ext cx="5904656" cy="6696744"/>
            <a:chOff x="-457200" y="0"/>
            <a:chExt cx="7315200" cy="7504113"/>
          </a:xfrm>
        </p:grpSpPr>
        <p:sp>
          <p:nvSpPr>
            <p:cNvPr id="4" name="Rectangle 21"/>
            <p:cNvSpPr>
              <a:spLocks noChangeArrowheads="1"/>
            </p:cNvSpPr>
            <p:nvPr/>
          </p:nvSpPr>
          <p:spPr bwMode="auto">
            <a:xfrm>
              <a:off x="342900" y="1268413"/>
              <a:ext cx="2228850" cy="6826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Records identified through database searching </a:t>
              </a:r>
              <a:b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5,388)</a:t>
              </a: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" name="AutoShape 23"/>
            <p:cNvSpPr>
              <a:spLocks noChangeArrowheads="1"/>
            </p:cNvSpPr>
            <p:nvPr/>
          </p:nvSpPr>
          <p:spPr bwMode="auto">
            <a:xfrm rot="16200000">
              <a:off x="-994569" y="31789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Times New Roman" pitchFamily="18" charset="0"/>
                </a:rPr>
                <a:t>Screening</a:t>
              </a:r>
              <a:endParaRPr kumimoji="0" lang="en-CA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AutoShape 3"/>
            <p:cNvSpPr>
              <a:spLocks noChangeArrowheads="1"/>
            </p:cNvSpPr>
            <p:nvPr/>
          </p:nvSpPr>
          <p:spPr bwMode="auto">
            <a:xfrm rot="16200000">
              <a:off x="-994569" y="63793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Times New Roman" pitchFamily="18" charset="0"/>
                </a:rPr>
                <a:t>Included</a:t>
              </a:r>
              <a:endParaRPr kumimoji="0" lang="en-CA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AutoShape 22"/>
            <p:cNvSpPr>
              <a:spLocks noChangeArrowheads="1"/>
            </p:cNvSpPr>
            <p:nvPr/>
          </p:nvSpPr>
          <p:spPr bwMode="auto">
            <a:xfrm rot="16200000">
              <a:off x="-994569" y="47791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1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Times New Roman" pitchFamily="18" charset="0"/>
                </a:rPr>
                <a:t>Eligibility</a:t>
              </a:r>
              <a:endParaRPr kumimoji="0" lang="en-CA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" name="AutoShape 20"/>
            <p:cNvSpPr>
              <a:spLocks noChangeShapeType="1"/>
            </p:cNvSpPr>
            <p:nvPr/>
          </p:nvSpPr>
          <p:spPr bwMode="auto">
            <a:xfrm>
              <a:off x="1600200" y="1954213"/>
              <a:ext cx="0" cy="457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9" name="AutoShape 19"/>
            <p:cNvSpPr>
              <a:spLocks noChangeShapeType="1"/>
            </p:cNvSpPr>
            <p:nvPr/>
          </p:nvSpPr>
          <p:spPr bwMode="auto">
            <a:xfrm>
              <a:off x="3886200" y="1954213"/>
              <a:ext cx="0" cy="457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10" name="AutoShape 4"/>
            <p:cNvSpPr>
              <a:spLocks noChangeArrowheads="1"/>
            </p:cNvSpPr>
            <p:nvPr/>
          </p:nvSpPr>
          <p:spPr bwMode="auto">
            <a:xfrm rot="16200000">
              <a:off x="-994569" y="1578769"/>
              <a:ext cx="1371600" cy="296862"/>
            </a:xfrm>
            <a:prstGeom prst="roundRect">
              <a:avLst>
                <a:gd name="adj" fmla="val 16667"/>
              </a:avLst>
            </a:prstGeom>
            <a:solidFill>
              <a:srgbClr val="CCECFF"/>
            </a:solidFill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45720" tIns="45720" rIns="45720" bIns="4572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cs typeface="Times New Roman" pitchFamily="18" charset="0"/>
                </a:rPr>
                <a:t>Identification</a:t>
              </a:r>
              <a:endParaRPr kumimoji="0" lang="en-CA" altLang="en-US" sz="1200" b="1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Times New Roman" pitchFamily="18" charset="0"/>
                <a:cs typeface="Times New Roman" pitchFamily="18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Rectangle 18"/>
            <p:cNvSpPr>
              <a:spLocks noChangeArrowheads="1"/>
            </p:cNvSpPr>
            <p:nvPr/>
          </p:nvSpPr>
          <p:spPr bwMode="auto">
            <a:xfrm>
              <a:off x="2914650" y="1268413"/>
              <a:ext cx="2228850" cy="6858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Additional records identified through other sources 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15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Rectangle 17"/>
            <p:cNvSpPr>
              <a:spLocks noChangeArrowheads="1"/>
            </p:cNvSpPr>
            <p:nvPr/>
          </p:nvSpPr>
          <p:spPr bwMode="auto">
            <a:xfrm>
              <a:off x="1357313" y="2411413"/>
              <a:ext cx="2771775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Records after duplicates removed 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5,403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Rectangle 16"/>
            <p:cNvSpPr>
              <a:spLocks noChangeArrowheads="1"/>
            </p:cNvSpPr>
            <p:nvPr/>
          </p:nvSpPr>
          <p:spPr bwMode="auto">
            <a:xfrm>
              <a:off x="1683835" y="3440113"/>
              <a:ext cx="1894392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Records screened 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5,403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" name="Rectangle 15"/>
            <p:cNvSpPr>
              <a:spLocks noChangeArrowheads="1"/>
            </p:cNvSpPr>
            <p:nvPr/>
          </p:nvSpPr>
          <p:spPr bwMode="auto">
            <a:xfrm>
              <a:off x="4229100" y="3440113"/>
              <a:ext cx="1879600" cy="5715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Records excluded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5,300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1683835" y="4354513"/>
              <a:ext cx="1916615" cy="6858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Full-text articles assessed for eligibility 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103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Rectangle 13"/>
            <p:cNvSpPr>
              <a:spLocks noChangeArrowheads="1"/>
            </p:cNvSpPr>
            <p:nvPr/>
          </p:nvSpPr>
          <p:spPr bwMode="auto">
            <a:xfrm>
              <a:off x="4229100" y="4354513"/>
              <a:ext cx="2182852" cy="1714502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Full-text articles excluded, with reason(s) </a:t>
              </a:r>
              <a:b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</a:t>
              </a: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22)</a:t>
              </a:r>
              <a:endParaRPr kumimoji="0" lang="en-CA" alt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No original data (n=2)</a:t>
              </a:r>
              <a:endParaRPr kumimoji="0" lang="en-CA" alt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No eligible data (</a:t>
              </a: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n=7)</a:t>
              </a:r>
              <a:endParaRPr kumimoji="0" lang="en-CA" alt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BD data not separable from other diagnoses (n=6) </a:t>
              </a:r>
              <a:endParaRPr kumimoji="0" lang="en-CA" altLang="en-US" sz="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Less than 3 BD cases (n=7)</a:t>
              </a: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Rectangle 12"/>
            <p:cNvSpPr>
              <a:spLocks noChangeArrowheads="1"/>
            </p:cNvSpPr>
            <p:nvPr/>
          </p:nvSpPr>
          <p:spPr bwMode="auto">
            <a:xfrm>
              <a:off x="1683835" y="5383213"/>
              <a:ext cx="1916615" cy="6858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Studies included in qualitative synthesis </a:t>
              </a:r>
              <a:b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 </a:t>
              </a:r>
              <a:r>
                <a:rPr lang="en-CA" altLang="en-US" sz="1100" dirty="0" smtClean="0">
                  <a:solidFill>
                    <a:srgbClr val="000000"/>
                  </a:solidFill>
                  <a:latin typeface="Calibri" pitchFamily="34" charset="0"/>
                  <a:ea typeface="Times New Roman" pitchFamily="18" charset="0"/>
                  <a:cs typeface="Arial" pitchFamily="34" charset="0"/>
                </a:rPr>
                <a:t>81</a:t>
              </a:r>
              <a:r>
                <a:rPr kumimoji="0" lang="en-CA" alt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)</a:t>
              </a:r>
              <a:endParaRPr kumimoji="0" lang="en-CA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Rectangle 11"/>
            <p:cNvSpPr>
              <a:spLocks noChangeArrowheads="1"/>
            </p:cNvSpPr>
            <p:nvPr/>
          </p:nvSpPr>
          <p:spPr bwMode="auto">
            <a:xfrm>
              <a:off x="1683835" y="6411913"/>
              <a:ext cx="1916615" cy="10922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91440" rIns="91440" bIns="91440" numCol="1" anchor="t" anchorCtr="0" compatLnSpc="1">
              <a:prstTxWarp prst="textNoShape">
                <a:avLst/>
              </a:prstTxWarp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Studies included in quantitative synthesis </a:t>
              </a:r>
              <a:b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</a:br>
              <a:r>
                <a:rPr kumimoji="0" lang="en-CA" altLang="en-US" sz="11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itchFamily="34" charset="0"/>
                  <a:ea typeface="Times New Roman" pitchFamily="18" charset="0"/>
                  <a:cs typeface="Arial" pitchFamily="34" charset="0"/>
                </a:rPr>
                <a:t>(n =  14 studies,  contributing to 11 meta-analyses)</a:t>
              </a:r>
              <a:endParaRPr kumimoji="0" lang="en-CA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AutoShape 10"/>
            <p:cNvSpPr>
              <a:spLocks noChangeShapeType="1"/>
            </p:cNvSpPr>
            <p:nvPr/>
          </p:nvSpPr>
          <p:spPr bwMode="auto">
            <a:xfrm>
              <a:off x="2618678" y="2985506"/>
              <a:ext cx="0" cy="4572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0" name="AutoShape 9"/>
            <p:cNvSpPr>
              <a:spLocks noChangeShapeType="1"/>
            </p:cNvSpPr>
            <p:nvPr/>
          </p:nvSpPr>
          <p:spPr bwMode="auto">
            <a:xfrm>
              <a:off x="2743200" y="4011613"/>
              <a:ext cx="0" cy="3429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1" name="AutoShape 8"/>
            <p:cNvSpPr>
              <a:spLocks noChangeShapeType="1"/>
            </p:cNvSpPr>
            <p:nvPr/>
          </p:nvSpPr>
          <p:spPr bwMode="auto">
            <a:xfrm>
              <a:off x="2743200" y="5040313"/>
              <a:ext cx="0" cy="3429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2" name="AutoShape 7"/>
            <p:cNvSpPr>
              <a:spLocks noChangeShapeType="1"/>
            </p:cNvSpPr>
            <p:nvPr/>
          </p:nvSpPr>
          <p:spPr bwMode="auto">
            <a:xfrm>
              <a:off x="2743200" y="6069013"/>
              <a:ext cx="0" cy="34290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3" name="AutoShape 6"/>
            <p:cNvSpPr>
              <a:spLocks noChangeShapeType="1"/>
            </p:cNvSpPr>
            <p:nvPr/>
          </p:nvSpPr>
          <p:spPr bwMode="auto">
            <a:xfrm>
              <a:off x="3578225" y="3725863"/>
              <a:ext cx="650875" cy="0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4" name="AutoShape 5"/>
            <p:cNvSpPr>
              <a:spLocks noChangeShapeType="1"/>
            </p:cNvSpPr>
            <p:nvPr/>
          </p:nvSpPr>
          <p:spPr bwMode="auto">
            <a:xfrm>
              <a:off x="3600450" y="4697413"/>
              <a:ext cx="628650" cy="447675"/>
            </a:xfrm>
            <a:prstGeom prst="straightConnector1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CCCCCC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5" name="Rectangle 24"/>
            <p:cNvSpPr>
              <a:spLocks noChangeArrowheads="1"/>
            </p:cNvSpPr>
            <p:nvPr/>
          </p:nvSpPr>
          <p:spPr bwMode="auto">
            <a:xfrm>
              <a:off x="0" y="0"/>
              <a:ext cx="6858000" cy="457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en-GB"/>
            </a:p>
          </p:txBody>
        </p:sp>
        <p:sp>
          <p:nvSpPr>
            <p:cNvPr id="26" name="Rectangle 38"/>
            <p:cNvSpPr>
              <a:spLocks noChangeArrowheads="1"/>
            </p:cNvSpPr>
            <p:nvPr/>
          </p:nvSpPr>
          <p:spPr bwMode="auto">
            <a:xfrm>
              <a:off x="0" y="457200"/>
              <a:ext cx="6858000" cy="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9" name="Rectangle 28"/>
          <p:cNvSpPr/>
          <p:nvPr/>
        </p:nvSpPr>
        <p:spPr>
          <a:xfrm>
            <a:off x="585588" y="665609"/>
            <a:ext cx="56886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. PRISMA diagram  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0619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585588" y="665609"/>
            <a:ext cx="5688632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Meta-analysis of layer thickness in non-subgenual ACC. </a:t>
            </a:r>
          </a:p>
        </p:txBody>
      </p:sp>
      <p:pic>
        <p:nvPicPr>
          <p:cNvPr id="2050" name="Picture 2" descr="H:\MyFiles\papers\Bipolar neuropath systematic review\ACC_nonsubgenual_thicknes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40879" y="1424608"/>
            <a:ext cx="5656262" cy="37708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4413870" y="5025008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30823296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harrison\Desktop\PFC_PV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3396" y="1625463"/>
            <a:ext cx="5616028" cy="42636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49275" y="704528"/>
            <a:ext cx="534312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. Density of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rvalbumin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ositive neurons in DLPFC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262179" y="5745088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2095615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49275" y="704528"/>
            <a:ext cx="5121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. Density of </a:t>
            </a:r>
            <a:r>
              <a:rPr lang="en-GB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retinin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-positive neurons in DLPFC</a:t>
            </a:r>
          </a:p>
        </p:txBody>
      </p:sp>
      <p:pic>
        <p:nvPicPr>
          <p:cNvPr id="1028" name="Picture 4" descr="C:\Users\harrison\Desktop\DPFC_calretinin_ND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40289" y="1712640"/>
            <a:ext cx="5836600" cy="4536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4442503" y="6089806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1761612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543188" y="658361"/>
            <a:ext cx="41349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Thickness of DLPFC grey matter</a:t>
            </a:r>
          </a:p>
        </p:txBody>
      </p:sp>
      <p:pic>
        <p:nvPicPr>
          <p:cNvPr id="5" name="Picture 2" descr="C:\Users\harrison\Desktop\DPFC_thickness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781" y="1219023"/>
            <a:ext cx="5688632" cy="10038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582233" y="3075275"/>
            <a:ext cx="53799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6. Density of oligodendrocytes in DLPFC white matter</a:t>
            </a:r>
          </a:p>
        </p:txBody>
      </p:sp>
      <p:pic>
        <p:nvPicPr>
          <p:cNvPr id="7" name="Picture 3" descr="C:\Users\harrison\Desktop\DOFC_WM_oligo_density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97781" y="3584848"/>
            <a:ext cx="5678822" cy="95308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4411912" y="2070349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  <p:sp>
        <p:nvSpPr>
          <p:cNvPr id="9" name="TextBox 8"/>
          <p:cNvSpPr txBox="1"/>
          <p:nvPr/>
        </p:nvSpPr>
        <p:spPr>
          <a:xfrm>
            <a:off x="4479643" y="4377516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  <p:sp>
        <p:nvSpPr>
          <p:cNvPr id="10" name="TextBox 9"/>
          <p:cNvSpPr txBox="1"/>
          <p:nvPr/>
        </p:nvSpPr>
        <p:spPr>
          <a:xfrm>
            <a:off x="548680" y="5457056"/>
            <a:ext cx="40446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Hippocampal neuronal number </a:t>
            </a:r>
          </a:p>
        </p:txBody>
      </p:sp>
      <p:pic>
        <p:nvPicPr>
          <p:cNvPr id="11" name="Picture 2" descr="H:\MyFiles\papers\Bipolar neuropath systematic review\Hippocampal neuron numb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1879" y="6105127"/>
            <a:ext cx="5751039" cy="30446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4479643" y="8986028"/>
            <a:ext cx="216024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800" dirty="0" smtClean="0"/>
              <a:t>Reduced in BD	Increased in BD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2002901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4</TotalTime>
  <Words>128</Words>
  <Application>Microsoft Office PowerPoint</Application>
  <PresentationFormat>A4 Paper (210x297 mm)</PresentationFormat>
  <Paragraphs>30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Oxfor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 Harrison</dc:creator>
  <cp:lastModifiedBy>Paul Harrison</cp:lastModifiedBy>
  <cp:revision>25</cp:revision>
  <cp:lastPrinted>2018-04-25T08:18:20Z</cp:lastPrinted>
  <dcterms:created xsi:type="dcterms:W3CDTF">2018-04-23T08:14:58Z</dcterms:created>
  <dcterms:modified xsi:type="dcterms:W3CDTF">2018-06-14T17:19:15Z</dcterms:modified>
</cp:coreProperties>
</file>